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89281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5F004-86ED-4879-80D2-536E69ED55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0E1D2-B5DA-405E-A8C7-E040C3310F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2D82D-8DEA-4FDC-BE9E-7FD2E68FE4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F837B-26A9-4E54-9FA8-CD76B413F3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01"/>
              </a:spcBef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F258E-5AAE-40CD-AC5F-D478D039FC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9C13D-9DC5-4946-8155-3C96162749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70ACA-2177-4DF8-A877-636EA7F00C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7F2A7-53F8-488C-A5AE-D809A5D22F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474480"/>
            <a:ext cx="10515600" cy="79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01"/>
              </a:spcBef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40B51-9CF8-42A1-900F-35EAA7694E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8A2AA-9BB2-4C54-BF1E-C1F9A176D7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1F2C8-7E67-48A6-A382-6E5B7B6BA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CE4EE-0066-4DF2-BD4D-45EF452AC5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9700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1" marL="89208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2" marL="148752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3" marL="208296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4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5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6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8275680"/>
            <a:ext cx="41148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B144C93-9003-437A-8B33-18A11C7700CA}" type="slidenum"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"/>
          <p:cNvPicPr/>
          <p:nvPr/>
        </p:nvPicPr>
        <p:blipFill>
          <a:blip r:embed="rId1"/>
          <a:stretch/>
        </p:blipFill>
        <p:spPr>
          <a:xfrm>
            <a:off x="957240" y="1582560"/>
            <a:ext cx="4130640" cy="407376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4"/>
          <p:cNvSpPr/>
          <p:nvPr/>
        </p:nvSpPr>
        <p:spPr>
          <a:xfrm>
            <a:off x="3103560" y="3324240"/>
            <a:ext cx="83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100%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5"/>
          <p:cNvSpPr/>
          <p:nvPr/>
        </p:nvSpPr>
        <p:spPr>
          <a:xfrm>
            <a:off x="1897200" y="4276800"/>
            <a:ext cx="696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50%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"/>
          <p:cNvSpPr/>
          <p:nvPr/>
        </p:nvSpPr>
        <p:spPr>
          <a:xfrm>
            <a:off x="1897200" y="2575080"/>
            <a:ext cx="696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50%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4153"/>
          <p:cNvSpPr/>
          <p:nvPr/>
        </p:nvSpPr>
        <p:spPr>
          <a:xfrm>
            <a:off x="4997520" y="1069920"/>
            <a:ext cx="73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4153"/>
          <p:cNvSpPr/>
          <p:nvPr/>
        </p:nvSpPr>
        <p:spPr>
          <a:xfrm>
            <a:off x="758880" y="1069920"/>
            <a:ext cx="73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图片 9" descr=""/>
          <p:cNvPicPr/>
          <p:nvPr/>
        </p:nvPicPr>
        <p:blipFill>
          <a:blip r:embed="rId2"/>
          <a:stretch/>
        </p:blipFill>
        <p:spPr>
          <a:xfrm>
            <a:off x="5365800" y="1407960"/>
            <a:ext cx="6245280" cy="409752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7080"/>
          <p:cNvSpPr/>
          <p:nvPr/>
        </p:nvSpPr>
        <p:spPr>
          <a:xfrm>
            <a:off x="997920" y="6066000"/>
            <a:ext cx="10702440" cy="13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Figure S4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. The frequencies of JAK2 gain and amplification, and their survival analysis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a,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The frequencies of JAK2 gain and amplification in DLBCL_JAK2/PD-L2_amp and PMBCL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b,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the OS and PFS of DLBCL with JAK2 gain or with JAK2 amplification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14T04:27:50Z</dcterms:created>
  <dc:creator>XMX</dc:creator>
  <dc:description/>
  <dc:language>en-US</dc:language>
  <cp:lastModifiedBy>XMX</cp:lastModifiedBy>
  <cp:lastPrinted>2019-03-19T11:17:35Z</cp:lastPrinted>
  <dcterms:modified xsi:type="dcterms:W3CDTF">2020-06-14T16:01:24Z</dcterms:modified>
  <cp:revision>181</cp:revision>
  <dc:subject/>
  <dc:title>PowerPoint 演示文稿</dc:title>
</cp:coreProperties>
</file>